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theme/themeOverride1.xml" ContentType="application/vnd.openxmlformats-officedocument.themeOverride+xml"/>
  <Override PartName="/ppt/charts/chart5.xml" ContentType="application/vnd.openxmlformats-officedocument.drawingml.chart+xml"/>
  <Override PartName="/ppt/theme/themeOverride2.xml" ContentType="application/vnd.openxmlformats-officedocument.themeOverride+xml"/>
  <Override PartName="/ppt/charts/chart6.xml" ContentType="application/vnd.openxmlformats-officedocument.drawingml.chart+xml"/>
  <Override PartName="/ppt/theme/themeOverride3.xml" ContentType="application/vnd.openxmlformats-officedocument.themeOverride+xml"/>
  <Override PartName="/ppt/charts/chart7.xml" ContentType="application/vnd.openxmlformats-officedocument.drawingml.chart+xml"/>
  <Override PartName="/ppt/theme/themeOverride4.xml" ContentType="application/vnd.openxmlformats-officedocument.themeOverride+xml"/>
  <Override PartName="/ppt/charts/chart8.xml" ContentType="application/vnd.openxmlformats-officedocument.drawingml.chart+xml"/>
  <Override PartName="/ppt/theme/themeOverride5.xml" ContentType="application/vnd.openxmlformats-officedocument.themeOverride+xml"/>
  <Override PartName="/ppt/charts/chart9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3" d="100"/>
          <a:sy n="73" d="100"/>
        </p:scale>
        <p:origin x="-1815" y="-15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1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5.xlsx"/><Relationship Id="rId1" Type="http://schemas.openxmlformats.org/officeDocument/2006/relationships/themeOverride" Target="../theme/themeOverride2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6.xlsx"/><Relationship Id="rId1" Type="http://schemas.openxmlformats.org/officeDocument/2006/relationships/themeOverride" Target="../theme/themeOverride3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7.xlsx"/><Relationship Id="rId1" Type="http://schemas.openxmlformats.org/officeDocument/2006/relationships/themeOverride" Target="../theme/themeOverride4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8.xlsx"/><Relationship Id="rId1" Type="http://schemas.openxmlformats.org/officeDocument/2006/relationships/themeOverride" Target="../theme/themeOverride5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9.xlsx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129608798900101"/>
          <c:y val="0.15066535433070899"/>
          <c:w val="0.88988100517774105"/>
          <c:h val="0.783131889763780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7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118:$A$146</c:f>
              <c:numCache>
                <c:formatCode>General</c:formatCode>
                <c:ptCount val="29"/>
              </c:numCache>
            </c:numRef>
          </c:cat>
          <c:val>
            <c:numRef>
              <c:f>Sheet1!$B$118:$B$146</c:f>
              <c:numCache>
                <c:formatCode>General</c:formatCode>
                <c:ptCount val="29"/>
                <c:pt idx="0">
                  <c:v>2.2129409582664379</c:v>
                </c:pt>
                <c:pt idx="1">
                  <c:v>6.7786663406832561</c:v>
                </c:pt>
                <c:pt idx="2">
                  <c:v>1.3730774077456409</c:v>
                </c:pt>
                <c:pt idx="3">
                  <c:v>0.49946585525905102</c:v>
                </c:pt>
                <c:pt idx="4">
                  <c:v>4.2952227763752102</c:v>
                </c:pt>
                <c:pt idx="5">
                  <c:v>11.23398175804908</c:v>
                </c:pt>
                <c:pt idx="6">
                  <c:v>3.181260383833342</c:v>
                </c:pt>
                <c:pt idx="7">
                  <c:v>3.2576575652257622</c:v>
                </c:pt>
                <c:pt idx="8">
                  <c:v>0.19574603097236701</c:v>
                </c:pt>
                <c:pt idx="9">
                  <c:v>1.989093316170238</c:v>
                </c:pt>
                <c:pt idx="10">
                  <c:v>4.5158856662521192</c:v>
                </c:pt>
                <c:pt idx="13">
                  <c:v>0.79437848818477497</c:v>
                </c:pt>
                <c:pt idx="14">
                  <c:v>4.9947638172180886</c:v>
                </c:pt>
                <c:pt idx="15">
                  <c:v>0.55159067032509301</c:v>
                </c:pt>
                <c:pt idx="16">
                  <c:v>1.6588833711223341</c:v>
                </c:pt>
                <c:pt idx="17">
                  <c:v>3.0773167745092671</c:v>
                </c:pt>
                <c:pt idx="18">
                  <c:v>0.49486347217757698</c:v>
                </c:pt>
                <c:pt idx="19">
                  <c:v>1.6438212866015021</c:v>
                </c:pt>
                <c:pt idx="20">
                  <c:v>1.306180214581586</c:v>
                </c:pt>
                <c:pt idx="21">
                  <c:v>14.246367535972929</c:v>
                </c:pt>
                <c:pt idx="22">
                  <c:v>0.75181153729022598</c:v>
                </c:pt>
                <c:pt idx="25">
                  <c:v>3.445427405012615</c:v>
                </c:pt>
                <c:pt idx="26">
                  <c:v>0.92550613606382903</c:v>
                </c:pt>
                <c:pt idx="27">
                  <c:v>0.35784902655167</c:v>
                </c:pt>
                <c:pt idx="28">
                  <c:v>3.3853639932390331</c:v>
                </c:pt>
              </c:numCache>
            </c:numRef>
          </c:val>
        </c:ser>
        <c:ser>
          <c:idx val="1"/>
          <c:order val="1"/>
          <c:tx>
            <c:strRef>
              <c:f>Sheet1!$C$107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118:$A$146</c:f>
              <c:numCache>
                <c:formatCode>General</c:formatCode>
                <c:ptCount val="29"/>
              </c:numCache>
            </c:numRef>
          </c:cat>
          <c:val>
            <c:numRef>
              <c:f>Sheet1!$C$118:$C$146</c:f>
              <c:numCache>
                <c:formatCode>General</c:formatCode>
                <c:ptCount val="29"/>
                <c:pt idx="0">
                  <c:v>0.195008235854359</c:v>
                </c:pt>
                <c:pt idx="1">
                  <c:v>0.18733085652176501</c:v>
                </c:pt>
                <c:pt idx="2">
                  <c:v>3.2764146726341341</c:v>
                </c:pt>
                <c:pt idx="3">
                  <c:v>30.48237610254311</c:v>
                </c:pt>
                <c:pt idx="4">
                  <c:v>7.313989016873256</c:v>
                </c:pt>
                <c:pt idx="5">
                  <c:v>0.159413637611481</c:v>
                </c:pt>
                <c:pt idx="6">
                  <c:v>0.38813971389004298</c:v>
                </c:pt>
                <c:pt idx="7">
                  <c:v>2.1399760493048699E-2</c:v>
                </c:pt>
                <c:pt idx="8">
                  <c:v>7.5005097633531401E-2</c:v>
                </c:pt>
                <c:pt idx="9">
                  <c:v>0.27383816978173797</c:v>
                </c:pt>
                <c:pt idx="10">
                  <c:v>1.5802662496938801E-2</c:v>
                </c:pt>
                <c:pt idx="13">
                  <c:v>1.092972771259608</c:v>
                </c:pt>
                <c:pt idx="14">
                  <c:v>0.169838384688525</c:v>
                </c:pt>
                <c:pt idx="15">
                  <c:v>8.9349364013894057</c:v>
                </c:pt>
                <c:pt idx="16">
                  <c:v>6.7273468833353306E-2</c:v>
                </c:pt>
                <c:pt idx="17">
                  <c:v>0.20200185691862699</c:v>
                </c:pt>
                <c:pt idx="18">
                  <c:v>68.900328690595984</c:v>
                </c:pt>
                <c:pt idx="19">
                  <c:v>0.95232833283002205</c:v>
                </c:pt>
                <c:pt idx="20">
                  <c:v>6.6723300308960204E-2</c:v>
                </c:pt>
                <c:pt idx="21">
                  <c:v>1.413741607873348</c:v>
                </c:pt>
                <c:pt idx="22">
                  <c:v>6.5467784164734394E-2</c:v>
                </c:pt>
                <c:pt idx="25">
                  <c:v>1.46839046355872E-2</c:v>
                </c:pt>
                <c:pt idx="26">
                  <c:v>2.8673547375356701E-2</c:v>
                </c:pt>
                <c:pt idx="27">
                  <c:v>0.200608474877571</c:v>
                </c:pt>
                <c:pt idx="28">
                  <c:v>0.2671485256409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358528"/>
        <c:axId val="48360064"/>
      </c:barChart>
      <c:catAx>
        <c:axId val="48358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crossAx val="48360064"/>
        <c:crossesAt val="0.01"/>
        <c:auto val="1"/>
        <c:lblAlgn val="ctr"/>
        <c:lblOffset val="100"/>
        <c:noMultiLvlLbl val="0"/>
      </c:catAx>
      <c:valAx>
        <c:axId val="48360064"/>
        <c:scaling>
          <c:logBase val="10"/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100" b="1">
                <a:latin typeface="+mj-lt"/>
                <a:cs typeface="Times New Roman" pitchFamily="18" charset="0"/>
              </a:defRPr>
            </a:pPr>
            <a:endParaRPr lang="zh-CN"/>
          </a:p>
        </c:txPr>
        <c:crossAx val="483585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6251220482750598"/>
          <c:y val="5.8188976377952801E-3"/>
          <c:w val="0.57483682872498598"/>
          <c:h val="0.19001902887139099"/>
        </c:manualLayout>
      </c:layout>
      <c:overlay val="0"/>
      <c:txPr>
        <a:bodyPr/>
        <a:lstStyle/>
        <a:p>
          <a:pPr>
            <a:defRPr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23047706500299"/>
          <c:y val="0.13375961571794201"/>
          <c:w val="0.86076952293499698"/>
          <c:h val="0.804438159511851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18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119:$A$147</c:f>
              <c:numCache>
                <c:formatCode>General</c:formatCode>
                <c:ptCount val="29"/>
              </c:numCache>
            </c:numRef>
          </c:cat>
          <c:val>
            <c:numRef>
              <c:f>Sheet1!$B$119:$B$147</c:f>
              <c:numCache>
                <c:formatCode>General</c:formatCode>
                <c:ptCount val="29"/>
                <c:pt idx="0">
                  <c:v>10.44655643354622</c:v>
                </c:pt>
                <c:pt idx="1">
                  <c:v>12.76811415828108</c:v>
                </c:pt>
                <c:pt idx="2">
                  <c:v>5.0165309479969444</c:v>
                </c:pt>
                <c:pt idx="3">
                  <c:v>10.01733297955462</c:v>
                </c:pt>
                <c:pt idx="4">
                  <c:v>6.2051261930060218</c:v>
                </c:pt>
                <c:pt idx="5">
                  <c:v>3.7926534441823199</c:v>
                </c:pt>
                <c:pt idx="6">
                  <c:v>12.17473993941088</c:v>
                </c:pt>
                <c:pt idx="7">
                  <c:v>16.27723279610337</c:v>
                </c:pt>
                <c:pt idx="8">
                  <c:v>4.2517434595741497</c:v>
                </c:pt>
                <c:pt idx="9">
                  <c:v>3.0749821816177971</c:v>
                </c:pt>
                <c:pt idx="10">
                  <c:v>4.3646895758983346</c:v>
                </c:pt>
                <c:pt idx="13">
                  <c:v>13.2028140233184</c:v>
                </c:pt>
                <c:pt idx="14">
                  <c:v>5.2766637441429403</c:v>
                </c:pt>
                <c:pt idx="15">
                  <c:v>2.6263706823416308</c:v>
                </c:pt>
                <c:pt idx="16">
                  <c:v>9.2180912601692988</c:v>
                </c:pt>
                <c:pt idx="17">
                  <c:v>11.66474650731972</c:v>
                </c:pt>
                <c:pt idx="18">
                  <c:v>8.8368613629338633</c:v>
                </c:pt>
                <c:pt idx="19">
                  <c:v>5.0497958007366446</c:v>
                </c:pt>
                <c:pt idx="20">
                  <c:v>8.8577424557244004</c:v>
                </c:pt>
                <c:pt idx="21">
                  <c:v>9.05859968954503</c:v>
                </c:pt>
                <c:pt idx="22">
                  <c:v>3.629971070654348</c:v>
                </c:pt>
                <c:pt idx="25">
                  <c:v>7.5980228493588484</c:v>
                </c:pt>
                <c:pt idx="26">
                  <c:v>5.6649787745628943</c:v>
                </c:pt>
                <c:pt idx="27">
                  <c:v>9.8530443474201093</c:v>
                </c:pt>
                <c:pt idx="28">
                  <c:v>10.84476247993797</c:v>
                </c:pt>
              </c:numCache>
            </c:numRef>
          </c:val>
        </c:ser>
        <c:ser>
          <c:idx val="1"/>
          <c:order val="1"/>
          <c:tx>
            <c:strRef>
              <c:f>Sheet1!$C$118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119:$A$147</c:f>
              <c:numCache>
                <c:formatCode>General</c:formatCode>
                <c:ptCount val="29"/>
              </c:numCache>
            </c:numRef>
          </c:cat>
          <c:val>
            <c:numRef>
              <c:f>Sheet1!$C$119:$C$147</c:f>
              <c:numCache>
                <c:formatCode>General</c:formatCode>
                <c:ptCount val="29"/>
                <c:pt idx="0">
                  <c:v>8.7193376703111785</c:v>
                </c:pt>
                <c:pt idx="1">
                  <c:v>10.827813590343601</c:v>
                </c:pt>
                <c:pt idx="2">
                  <c:v>4.7055506226187687</c:v>
                </c:pt>
                <c:pt idx="3">
                  <c:v>0.94720939822626904</c:v>
                </c:pt>
                <c:pt idx="4">
                  <c:v>3.7868651571507752</c:v>
                </c:pt>
                <c:pt idx="5">
                  <c:v>45.608902533940039</c:v>
                </c:pt>
                <c:pt idx="6">
                  <c:v>18.110507262297141</c:v>
                </c:pt>
                <c:pt idx="7">
                  <c:v>0.25327350169934199</c:v>
                </c:pt>
                <c:pt idx="8">
                  <c:v>6.5415660161261497</c:v>
                </c:pt>
                <c:pt idx="9">
                  <c:v>8.7977984492049206</c:v>
                </c:pt>
                <c:pt idx="10">
                  <c:v>0.58781050633328302</c:v>
                </c:pt>
                <c:pt idx="13">
                  <c:v>1.4934837606079681</c:v>
                </c:pt>
                <c:pt idx="14">
                  <c:v>17.02463013610544</c:v>
                </c:pt>
                <c:pt idx="15">
                  <c:v>18.618933739973851</c:v>
                </c:pt>
                <c:pt idx="16">
                  <c:v>28.542524761821721</c:v>
                </c:pt>
                <c:pt idx="17">
                  <c:v>48.255987356009832</c:v>
                </c:pt>
                <c:pt idx="18">
                  <c:v>9.3362846704723168</c:v>
                </c:pt>
                <c:pt idx="19">
                  <c:v>5.2832422059633002</c:v>
                </c:pt>
                <c:pt idx="20">
                  <c:v>20.30532270558162</c:v>
                </c:pt>
                <c:pt idx="21">
                  <c:v>46.386723817283404</c:v>
                </c:pt>
                <c:pt idx="22">
                  <c:v>0.77850491384541298</c:v>
                </c:pt>
                <c:pt idx="25">
                  <c:v>61.923840752751303</c:v>
                </c:pt>
                <c:pt idx="26">
                  <c:v>1.6664635943397721</c:v>
                </c:pt>
                <c:pt idx="27">
                  <c:v>4.9597797315234802</c:v>
                </c:pt>
                <c:pt idx="28">
                  <c:v>11.7102831147002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4505856"/>
        <c:axId val="144528128"/>
      </c:barChart>
      <c:catAx>
        <c:axId val="144505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44528128"/>
        <c:crossesAt val="0.1"/>
        <c:auto val="1"/>
        <c:lblAlgn val="ctr"/>
        <c:lblOffset val="100"/>
        <c:noMultiLvlLbl val="0"/>
      </c:catAx>
      <c:valAx>
        <c:axId val="144528128"/>
        <c:scaling>
          <c:logBase val="10"/>
          <c:orientation val="minMax"/>
          <c:max val="100"/>
          <c:min val="0.1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j-lt"/>
                <a:ea typeface="Tahoma" pitchFamily="34" charset="0"/>
                <a:cs typeface="Times New Roman" pitchFamily="18" charset="0"/>
              </a:defRPr>
            </a:pPr>
            <a:endParaRPr lang="zh-CN"/>
          </a:p>
        </c:txPr>
        <c:crossAx val="1445058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05292531563325"/>
          <c:y val="8.7482511673600792E-3"/>
          <c:w val="0.71818963472372499"/>
          <c:h val="0.19364213079273199"/>
        </c:manualLayout>
      </c:layout>
      <c:overlay val="0"/>
      <c:txPr>
        <a:bodyPr/>
        <a:lstStyle/>
        <a:p>
          <a:pPr>
            <a:defRPr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900605810901499"/>
          <c:y val="0.12223416272205"/>
          <c:w val="0.90848110252042702"/>
          <c:h val="0.812585969963575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5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116:$A$144</c:f>
              <c:numCache>
                <c:formatCode>General</c:formatCode>
                <c:ptCount val="29"/>
              </c:numCache>
            </c:numRef>
          </c:cat>
          <c:val>
            <c:numRef>
              <c:f>Sheet1!$B$116:$B$144</c:f>
              <c:numCache>
                <c:formatCode>General</c:formatCode>
                <c:ptCount val="29"/>
                <c:pt idx="0">
                  <c:v>0.80674359025649101</c:v>
                </c:pt>
                <c:pt idx="1">
                  <c:v>1.331602159598352</c:v>
                </c:pt>
                <c:pt idx="2">
                  <c:v>0.28179279218356901</c:v>
                </c:pt>
                <c:pt idx="3">
                  <c:v>1.490238371007593</c:v>
                </c:pt>
                <c:pt idx="4">
                  <c:v>0.52896149610812204</c:v>
                </c:pt>
                <c:pt idx="5">
                  <c:v>0.65230727123157595</c:v>
                </c:pt>
                <c:pt idx="6">
                  <c:v>0.53214160741202798</c:v>
                </c:pt>
                <c:pt idx="7">
                  <c:v>0.79656672225115599</c:v>
                </c:pt>
                <c:pt idx="8">
                  <c:v>0.16419528621666499</c:v>
                </c:pt>
                <c:pt idx="9">
                  <c:v>2.9443376285036038</c:v>
                </c:pt>
                <c:pt idx="10">
                  <c:v>2.6558701550854109</c:v>
                </c:pt>
                <c:pt idx="13">
                  <c:v>1.4594948451772121</c:v>
                </c:pt>
                <c:pt idx="14">
                  <c:v>0.73731530800460898</c:v>
                </c:pt>
                <c:pt idx="15">
                  <c:v>0.34979404055307001</c:v>
                </c:pt>
                <c:pt idx="16">
                  <c:v>1.7397585715188679</c:v>
                </c:pt>
                <c:pt idx="17">
                  <c:v>1.253755574447678</c:v>
                </c:pt>
                <c:pt idx="18">
                  <c:v>2.027753965009357</c:v>
                </c:pt>
                <c:pt idx="19">
                  <c:v>2.382640211977646</c:v>
                </c:pt>
                <c:pt idx="20">
                  <c:v>0.56089557844065496</c:v>
                </c:pt>
                <c:pt idx="21">
                  <c:v>0.97619286712917697</c:v>
                </c:pt>
                <c:pt idx="22">
                  <c:v>1.5979520473693629</c:v>
                </c:pt>
                <c:pt idx="25">
                  <c:v>0.85724240085705805</c:v>
                </c:pt>
                <c:pt idx="26">
                  <c:v>7.3612441166427116</c:v>
                </c:pt>
                <c:pt idx="27">
                  <c:v>1.477842594108431</c:v>
                </c:pt>
                <c:pt idx="28">
                  <c:v>2.031265209258732</c:v>
                </c:pt>
              </c:numCache>
            </c:numRef>
          </c:val>
        </c:ser>
        <c:ser>
          <c:idx val="1"/>
          <c:order val="1"/>
          <c:tx>
            <c:strRef>
              <c:f>Sheet1!$C$105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116:$A$144</c:f>
              <c:numCache>
                <c:formatCode>General</c:formatCode>
                <c:ptCount val="29"/>
              </c:numCache>
            </c:numRef>
          </c:cat>
          <c:val>
            <c:numRef>
              <c:f>Sheet1!$C$116:$C$144</c:f>
              <c:numCache>
                <c:formatCode>General</c:formatCode>
                <c:ptCount val="29"/>
                <c:pt idx="0">
                  <c:v>0.84419641941800805</c:v>
                </c:pt>
                <c:pt idx="1">
                  <c:v>0.293026615538383</c:v>
                </c:pt>
                <c:pt idx="2">
                  <c:v>0.303376788860512</c:v>
                </c:pt>
                <c:pt idx="3">
                  <c:v>1.49101690553365</c:v>
                </c:pt>
                <c:pt idx="4">
                  <c:v>1.7887810442889202E-2</c:v>
                </c:pt>
                <c:pt idx="5">
                  <c:v>6.5898165576607895E-2</c:v>
                </c:pt>
                <c:pt idx="6">
                  <c:v>0.13425624618721399</c:v>
                </c:pt>
                <c:pt idx="7">
                  <c:v>2.1822823974111401E-2</c:v>
                </c:pt>
                <c:pt idx="8">
                  <c:v>0.31542559037409501</c:v>
                </c:pt>
                <c:pt idx="9">
                  <c:v>1.20077314371362</c:v>
                </c:pt>
                <c:pt idx="10">
                  <c:v>0.82492743067168495</c:v>
                </c:pt>
                <c:pt idx="13">
                  <c:v>7.7611573545304305E-2</c:v>
                </c:pt>
                <c:pt idx="14">
                  <c:v>3.0047819570968502E-2</c:v>
                </c:pt>
                <c:pt idx="15">
                  <c:v>0.37132506697827</c:v>
                </c:pt>
                <c:pt idx="16">
                  <c:v>0.31754525452806398</c:v>
                </c:pt>
                <c:pt idx="17">
                  <c:v>0.39448397909411298</c:v>
                </c:pt>
                <c:pt idx="18">
                  <c:v>21.350176854411931</c:v>
                </c:pt>
                <c:pt idx="19">
                  <c:v>1.2283601504671511</c:v>
                </c:pt>
                <c:pt idx="20">
                  <c:v>0.12838869817821499</c:v>
                </c:pt>
                <c:pt idx="21">
                  <c:v>0.792393041047325</c:v>
                </c:pt>
                <c:pt idx="22">
                  <c:v>1.592292208405182</c:v>
                </c:pt>
                <c:pt idx="25">
                  <c:v>0.19592441783690001</c:v>
                </c:pt>
                <c:pt idx="26">
                  <c:v>6.15476407026532E-2</c:v>
                </c:pt>
                <c:pt idx="27">
                  <c:v>0.21667252276259</c:v>
                </c:pt>
                <c:pt idx="28">
                  <c:v>0.676610333244855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2343552"/>
        <c:axId val="202345088"/>
      </c:barChart>
      <c:catAx>
        <c:axId val="202343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crossAx val="202345088"/>
        <c:crossesAt val="0.01"/>
        <c:auto val="1"/>
        <c:lblAlgn val="ctr"/>
        <c:lblOffset val="100"/>
        <c:noMultiLvlLbl val="0"/>
      </c:catAx>
      <c:valAx>
        <c:axId val="202345088"/>
        <c:scaling>
          <c:logBase val="10"/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100" b="1">
                <a:latin typeface="+mj-lt"/>
                <a:cs typeface="Times New Roman" pitchFamily="18" charset="0"/>
              </a:defRPr>
            </a:pPr>
            <a:endParaRPr lang="zh-CN"/>
          </a:p>
        </c:txPr>
        <c:crossAx val="2023435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48647225782824"/>
          <c:y val="2.02174537258393E-3"/>
          <c:w val="0.63991866569004496"/>
          <c:h val="0.14160262728787201"/>
        </c:manualLayout>
      </c:layout>
      <c:overlay val="0"/>
      <c:txPr>
        <a:bodyPr/>
        <a:lstStyle/>
        <a:p>
          <a:pPr>
            <a:defRPr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80190289059079"/>
          <c:y val="0.12358616101131099"/>
          <c:w val="0.81980971094092103"/>
          <c:h val="0.811155903416263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15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116:$A$144</c:f>
              <c:numCache>
                <c:formatCode>General</c:formatCode>
                <c:ptCount val="29"/>
              </c:numCache>
            </c:numRef>
          </c:cat>
          <c:val>
            <c:numRef>
              <c:f>Sheet1!$B$116:$B$144</c:f>
              <c:numCache>
                <c:formatCode>General</c:formatCode>
                <c:ptCount val="29"/>
                <c:pt idx="0">
                  <c:v>1.1686016576033811</c:v>
                </c:pt>
                <c:pt idx="1">
                  <c:v>5.0867448853925881</c:v>
                </c:pt>
                <c:pt idx="2">
                  <c:v>0.73380276242769604</c:v>
                </c:pt>
                <c:pt idx="3">
                  <c:v>2.2402927067941238</c:v>
                </c:pt>
                <c:pt idx="4">
                  <c:v>1.128043138979788</c:v>
                </c:pt>
                <c:pt idx="5">
                  <c:v>2.6045231146450041</c:v>
                </c:pt>
                <c:pt idx="6">
                  <c:v>8.7290747453278179</c:v>
                </c:pt>
                <c:pt idx="7">
                  <c:v>1.617595333914569</c:v>
                </c:pt>
                <c:pt idx="8">
                  <c:v>1.792515061067417</c:v>
                </c:pt>
                <c:pt idx="9">
                  <c:v>4.8599896478662217</c:v>
                </c:pt>
                <c:pt idx="10">
                  <c:v>2.935787896566405</c:v>
                </c:pt>
                <c:pt idx="13">
                  <c:v>27.646314053952821</c:v>
                </c:pt>
                <c:pt idx="14">
                  <c:v>2.3368963404621468</c:v>
                </c:pt>
                <c:pt idx="15">
                  <c:v>0.35353323235242301</c:v>
                </c:pt>
                <c:pt idx="16">
                  <c:v>4.3351404683605326</c:v>
                </c:pt>
                <c:pt idx="17">
                  <c:v>2.177360424785892</c:v>
                </c:pt>
                <c:pt idx="18">
                  <c:v>8.4192413590272999</c:v>
                </c:pt>
                <c:pt idx="19">
                  <c:v>14.150113703446269</c:v>
                </c:pt>
                <c:pt idx="20">
                  <c:v>13.089628441236311</c:v>
                </c:pt>
                <c:pt idx="21">
                  <c:v>1.0577049510025009</c:v>
                </c:pt>
                <c:pt idx="22">
                  <c:v>7.1396667696806873</c:v>
                </c:pt>
                <c:pt idx="25">
                  <c:v>12.533289763434169</c:v>
                </c:pt>
                <c:pt idx="26">
                  <c:v>3.452182514420655</c:v>
                </c:pt>
                <c:pt idx="27">
                  <c:v>20.21944848133446</c:v>
                </c:pt>
                <c:pt idx="28">
                  <c:v>8.9135877647336628</c:v>
                </c:pt>
              </c:numCache>
            </c:numRef>
          </c:val>
        </c:ser>
        <c:ser>
          <c:idx val="1"/>
          <c:order val="1"/>
          <c:tx>
            <c:strRef>
              <c:f>Sheet1!$C$115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116:$A$144</c:f>
              <c:numCache>
                <c:formatCode>General</c:formatCode>
                <c:ptCount val="29"/>
              </c:numCache>
            </c:numRef>
          </c:cat>
          <c:val>
            <c:numRef>
              <c:f>Sheet1!$C$116:$C$144</c:f>
              <c:numCache>
                <c:formatCode>General</c:formatCode>
                <c:ptCount val="29"/>
                <c:pt idx="0">
                  <c:v>15.802563870013239</c:v>
                </c:pt>
                <c:pt idx="1">
                  <c:v>17.787769881148201</c:v>
                </c:pt>
                <c:pt idx="2">
                  <c:v>14.407730951827039</c:v>
                </c:pt>
                <c:pt idx="3">
                  <c:v>27.00272763232369</c:v>
                </c:pt>
                <c:pt idx="4">
                  <c:v>12.465239877455829</c:v>
                </c:pt>
                <c:pt idx="5">
                  <c:v>25.456951160372899</c:v>
                </c:pt>
                <c:pt idx="6">
                  <c:v>18.22427150913072</c:v>
                </c:pt>
                <c:pt idx="7">
                  <c:v>16.449213968333879</c:v>
                </c:pt>
                <c:pt idx="8">
                  <c:v>5.636920578676766</c:v>
                </c:pt>
                <c:pt idx="9">
                  <c:v>20.45549778828088</c:v>
                </c:pt>
                <c:pt idx="10">
                  <c:v>100.3846409538108</c:v>
                </c:pt>
                <c:pt idx="13">
                  <c:v>32.758644138656997</c:v>
                </c:pt>
                <c:pt idx="14">
                  <c:v>35.128845070075677</c:v>
                </c:pt>
                <c:pt idx="15">
                  <c:v>9.5804056332163992</c:v>
                </c:pt>
                <c:pt idx="16">
                  <c:v>46.675586345202063</c:v>
                </c:pt>
                <c:pt idx="17">
                  <c:v>43.81317135506022</c:v>
                </c:pt>
                <c:pt idx="18">
                  <c:v>35.397626958456932</c:v>
                </c:pt>
                <c:pt idx="19">
                  <c:v>21.293168528479089</c:v>
                </c:pt>
                <c:pt idx="20">
                  <c:v>45.225553070462603</c:v>
                </c:pt>
                <c:pt idx="21">
                  <c:v>24.99939438754982</c:v>
                </c:pt>
                <c:pt idx="22">
                  <c:v>60.688436187544717</c:v>
                </c:pt>
                <c:pt idx="25">
                  <c:v>66.333499821069182</c:v>
                </c:pt>
                <c:pt idx="26">
                  <c:v>6.4461264570789076</c:v>
                </c:pt>
                <c:pt idx="27">
                  <c:v>25.101483774811761</c:v>
                </c:pt>
                <c:pt idx="28">
                  <c:v>39.9711240984862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7996416"/>
        <c:axId val="168010496"/>
      </c:barChart>
      <c:catAx>
        <c:axId val="167996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crossAx val="168010496"/>
        <c:crossesAt val="0.1"/>
        <c:auto val="1"/>
        <c:lblAlgn val="ctr"/>
        <c:lblOffset val="100"/>
        <c:noMultiLvlLbl val="0"/>
      </c:catAx>
      <c:valAx>
        <c:axId val="168010496"/>
        <c:scaling>
          <c:logBase val="10"/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00" b="1">
                <a:latin typeface="+mj-lt"/>
                <a:cs typeface="Times New Roman" pitchFamily="18" charset="0"/>
              </a:defRPr>
            </a:pPr>
            <a:endParaRPr lang="zh-CN"/>
          </a:p>
        </c:txPr>
        <c:crossAx val="16799641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2971225677432999"/>
          <c:y val="0"/>
          <c:w val="0.71608345685150199"/>
          <c:h val="0.198105756989957"/>
        </c:manualLayout>
      </c:layout>
      <c:overlay val="0"/>
      <c:txPr>
        <a:bodyPr/>
        <a:lstStyle/>
        <a:p>
          <a:pPr>
            <a:defRPr sz="1000" b="1">
              <a:latin typeface="+mj-lt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6213618202183304E-2"/>
          <c:y val="0.140219560878244"/>
          <c:w val="0.91378638179781602"/>
          <c:h val="0.794522503549331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3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104:$A$132</c:f>
              <c:numCache>
                <c:formatCode>General</c:formatCode>
                <c:ptCount val="29"/>
              </c:numCache>
            </c:numRef>
          </c:cat>
          <c:val>
            <c:numRef>
              <c:f>Sheet1!$B$104:$B$132</c:f>
              <c:numCache>
                <c:formatCode>General</c:formatCode>
                <c:ptCount val="29"/>
                <c:pt idx="0">
                  <c:v>6.7225045988427101E-2</c:v>
                </c:pt>
                <c:pt idx="1">
                  <c:v>0.38712480257394</c:v>
                </c:pt>
                <c:pt idx="2">
                  <c:v>0.53129669639449995</c:v>
                </c:pt>
                <c:pt idx="3">
                  <c:v>0.62433041155518898</c:v>
                </c:pt>
                <c:pt idx="4">
                  <c:v>5.9884168386418501</c:v>
                </c:pt>
                <c:pt idx="5">
                  <c:v>1.3554859386884079</c:v>
                </c:pt>
                <c:pt idx="6">
                  <c:v>0.67633791955494305</c:v>
                </c:pt>
                <c:pt idx="7">
                  <c:v>1.0542840722633251</c:v>
                </c:pt>
                <c:pt idx="8">
                  <c:v>0.64050740157335695</c:v>
                </c:pt>
                <c:pt idx="9">
                  <c:v>9.7902937491013979</c:v>
                </c:pt>
                <c:pt idx="10">
                  <c:v>0.45157394328991102</c:v>
                </c:pt>
                <c:pt idx="13">
                  <c:v>0.28504204561055702</c:v>
                </c:pt>
                <c:pt idx="14">
                  <c:v>0.45672546875933201</c:v>
                </c:pt>
                <c:pt idx="15">
                  <c:v>0.49331571355960302</c:v>
                </c:pt>
                <c:pt idx="16">
                  <c:v>0.228839205739608</c:v>
                </c:pt>
                <c:pt idx="17">
                  <c:v>1.478307248182626</c:v>
                </c:pt>
                <c:pt idx="18">
                  <c:v>0.26942939189673698</c:v>
                </c:pt>
                <c:pt idx="19">
                  <c:v>5.3187891166769398E-2</c:v>
                </c:pt>
                <c:pt idx="20">
                  <c:v>1.8546697749947098E-2</c:v>
                </c:pt>
                <c:pt idx="21">
                  <c:v>0.38625664216016198</c:v>
                </c:pt>
                <c:pt idx="22">
                  <c:v>0.387360471939522</c:v>
                </c:pt>
                <c:pt idx="25">
                  <c:v>0.21031499899586001</c:v>
                </c:pt>
                <c:pt idx="26">
                  <c:v>0.23120782770894499</c:v>
                </c:pt>
                <c:pt idx="27">
                  <c:v>0.15564548659337599</c:v>
                </c:pt>
                <c:pt idx="28">
                  <c:v>0.51210680927965302</c:v>
                </c:pt>
              </c:numCache>
            </c:numRef>
          </c:val>
        </c:ser>
        <c:ser>
          <c:idx val="1"/>
          <c:order val="1"/>
          <c:tx>
            <c:strRef>
              <c:f>Sheet1!$C$103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104:$A$132</c:f>
              <c:numCache>
                <c:formatCode>General</c:formatCode>
                <c:ptCount val="29"/>
              </c:numCache>
            </c:numRef>
          </c:cat>
          <c:val>
            <c:numRef>
              <c:f>Sheet1!$C$104:$C$132</c:f>
              <c:numCache>
                <c:formatCode>General</c:formatCode>
                <c:ptCount val="29"/>
                <c:pt idx="0">
                  <c:v>1.9626278633260199</c:v>
                </c:pt>
                <c:pt idx="1">
                  <c:v>4.2712775473687579</c:v>
                </c:pt>
                <c:pt idx="2">
                  <c:v>5.8632442083166856</c:v>
                </c:pt>
                <c:pt idx="3">
                  <c:v>4.448744201318708</c:v>
                </c:pt>
                <c:pt idx="4">
                  <c:v>1.3996558587791741</c:v>
                </c:pt>
                <c:pt idx="5">
                  <c:v>1.3905967734998581</c:v>
                </c:pt>
                <c:pt idx="6">
                  <c:v>18.2072565176761</c:v>
                </c:pt>
                <c:pt idx="7">
                  <c:v>13.13557679936098</c:v>
                </c:pt>
                <c:pt idx="8">
                  <c:v>29.908261502154399</c:v>
                </c:pt>
                <c:pt idx="9">
                  <c:v>13.918324534951299</c:v>
                </c:pt>
                <c:pt idx="10">
                  <c:v>1.75966420527228</c:v>
                </c:pt>
                <c:pt idx="13">
                  <c:v>7.8966768174974407</c:v>
                </c:pt>
                <c:pt idx="14">
                  <c:v>58.696197814986647</c:v>
                </c:pt>
                <c:pt idx="15">
                  <c:v>138.02627783096619</c:v>
                </c:pt>
                <c:pt idx="16">
                  <c:v>64.372123111505758</c:v>
                </c:pt>
                <c:pt idx="17">
                  <c:v>46.995318642708803</c:v>
                </c:pt>
                <c:pt idx="18">
                  <c:v>11.271066644916569</c:v>
                </c:pt>
                <c:pt idx="19">
                  <c:v>20.292590567284901</c:v>
                </c:pt>
                <c:pt idx="20">
                  <c:v>1.7570389182551911</c:v>
                </c:pt>
                <c:pt idx="21">
                  <c:v>93.186602488320332</c:v>
                </c:pt>
                <c:pt idx="22">
                  <c:v>4.9644887245976612</c:v>
                </c:pt>
                <c:pt idx="25">
                  <c:v>40.017736088086998</c:v>
                </c:pt>
                <c:pt idx="26">
                  <c:v>29.134399041876701</c:v>
                </c:pt>
                <c:pt idx="27">
                  <c:v>3.3647461058019572</c:v>
                </c:pt>
                <c:pt idx="28">
                  <c:v>5.36495528718020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133888"/>
        <c:axId val="204135424"/>
      </c:barChart>
      <c:catAx>
        <c:axId val="204133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crossAx val="204135424"/>
        <c:crossesAt val="0.01"/>
        <c:auto val="1"/>
        <c:lblAlgn val="ctr"/>
        <c:lblOffset val="100"/>
        <c:noMultiLvlLbl val="0"/>
      </c:catAx>
      <c:valAx>
        <c:axId val="204135424"/>
        <c:scaling>
          <c:logBase val="10"/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00" b="1">
                <a:latin typeface="+mj-lt"/>
                <a:cs typeface="Times New Roman" pitchFamily="18" charset="0"/>
              </a:defRPr>
            </a:pPr>
            <a:endParaRPr lang="zh-CN"/>
          </a:p>
        </c:txPr>
        <c:crossAx val="2041338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9144862644210401"/>
          <c:y val="8.4856533651856397E-3"/>
          <c:w val="0.64066728405057205"/>
          <c:h val="0.21126054976660899"/>
        </c:manualLayout>
      </c:layout>
      <c:overlay val="0"/>
      <c:txPr>
        <a:bodyPr/>
        <a:lstStyle/>
        <a:p>
          <a:pPr>
            <a:defRPr sz="1000"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5.8866159617611699E-2"/>
          <c:y val="0.13678875844112301"/>
          <c:w val="0.933899940531284"/>
          <c:h val="0.797953305986451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7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108:$A$136</c:f>
              <c:numCache>
                <c:formatCode>General</c:formatCode>
                <c:ptCount val="29"/>
              </c:numCache>
            </c:numRef>
          </c:cat>
          <c:val>
            <c:numRef>
              <c:f>Sheet1!$B$108:$B$136</c:f>
              <c:numCache>
                <c:formatCode>General</c:formatCode>
                <c:ptCount val="29"/>
                <c:pt idx="0">
                  <c:v>3.98077936498867</c:v>
                </c:pt>
                <c:pt idx="1">
                  <c:v>0.41001395322025003</c:v>
                </c:pt>
                <c:pt idx="2">
                  <c:v>1.7415717515170659</c:v>
                </c:pt>
                <c:pt idx="3">
                  <c:v>1.050645822487756</c:v>
                </c:pt>
                <c:pt idx="4">
                  <c:v>0.184256882257541</c:v>
                </c:pt>
                <c:pt idx="5">
                  <c:v>5.9793158112797054</c:v>
                </c:pt>
                <c:pt idx="6">
                  <c:v>1.6313540392256609</c:v>
                </c:pt>
                <c:pt idx="7">
                  <c:v>0.29055635452744399</c:v>
                </c:pt>
                <c:pt idx="8">
                  <c:v>2.0573837456655442</c:v>
                </c:pt>
                <c:pt idx="9">
                  <c:v>3.8225055649890198E-2</c:v>
                </c:pt>
                <c:pt idx="10">
                  <c:v>0.38741679745016</c:v>
                </c:pt>
                <c:pt idx="13">
                  <c:v>0.90005864565767602</c:v>
                </c:pt>
                <c:pt idx="14">
                  <c:v>0.63356011142809099</c:v>
                </c:pt>
                <c:pt idx="15">
                  <c:v>0.89346363248277205</c:v>
                </c:pt>
                <c:pt idx="16">
                  <c:v>2.5552658767715211</c:v>
                </c:pt>
                <c:pt idx="17">
                  <c:v>0.32048848158392201</c:v>
                </c:pt>
                <c:pt idx="18">
                  <c:v>0.59469317019171297</c:v>
                </c:pt>
                <c:pt idx="19">
                  <c:v>5.6870674383846334</c:v>
                </c:pt>
                <c:pt idx="20">
                  <c:v>4.3404192797369401</c:v>
                </c:pt>
                <c:pt idx="21">
                  <c:v>5.7910277583096628</c:v>
                </c:pt>
                <c:pt idx="22">
                  <c:v>0.66686582043905396</c:v>
                </c:pt>
                <c:pt idx="25" formatCode="###0.00;\-###0.00">
                  <c:v>0.46633622644093797</c:v>
                </c:pt>
                <c:pt idx="26" formatCode="###0.00;\-###0.00">
                  <c:v>0.32425588466356098</c:v>
                </c:pt>
                <c:pt idx="27" formatCode="###0.00;\-###0.00">
                  <c:v>2.453492586514745</c:v>
                </c:pt>
                <c:pt idx="28" formatCode="###0.00;\-###0.00">
                  <c:v>2.8568829176413901</c:v>
                </c:pt>
              </c:numCache>
            </c:numRef>
          </c:val>
        </c:ser>
        <c:ser>
          <c:idx val="1"/>
          <c:order val="1"/>
          <c:tx>
            <c:strRef>
              <c:f>Sheet1!$C$107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108:$A$136</c:f>
              <c:numCache>
                <c:formatCode>General</c:formatCode>
                <c:ptCount val="29"/>
              </c:numCache>
            </c:numRef>
          </c:cat>
          <c:val>
            <c:numRef>
              <c:f>Sheet1!$C$108:$C$136</c:f>
              <c:numCache>
                <c:formatCode>General</c:formatCode>
                <c:ptCount val="29"/>
                <c:pt idx="0">
                  <c:v>5.452233738594443</c:v>
                </c:pt>
                <c:pt idx="1">
                  <c:v>2.630758673214546</c:v>
                </c:pt>
                <c:pt idx="2">
                  <c:v>1.670308875395027</c:v>
                </c:pt>
                <c:pt idx="3">
                  <c:v>1.819495410540225</c:v>
                </c:pt>
                <c:pt idx="4">
                  <c:v>0.49738603677844501</c:v>
                </c:pt>
                <c:pt idx="5">
                  <c:v>11.90698637462414</c:v>
                </c:pt>
                <c:pt idx="6">
                  <c:v>5.2350049893704904</c:v>
                </c:pt>
                <c:pt idx="7">
                  <c:v>1.0621097953845979</c:v>
                </c:pt>
                <c:pt idx="8">
                  <c:v>3.2117607150996439</c:v>
                </c:pt>
                <c:pt idx="9">
                  <c:v>0.11138897975765</c:v>
                </c:pt>
                <c:pt idx="10">
                  <c:v>0.31585830520131097</c:v>
                </c:pt>
                <c:pt idx="13">
                  <c:v>1.558826013302764</c:v>
                </c:pt>
                <c:pt idx="14">
                  <c:v>2.3053070376990341</c:v>
                </c:pt>
                <c:pt idx="15">
                  <c:v>2.4324614011211181</c:v>
                </c:pt>
                <c:pt idx="16">
                  <c:v>1.402969759139471</c:v>
                </c:pt>
                <c:pt idx="17">
                  <c:v>0.30982552531754598</c:v>
                </c:pt>
                <c:pt idx="18">
                  <c:v>0.93457115312570505</c:v>
                </c:pt>
                <c:pt idx="19">
                  <c:v>6.5313599196888861</c:v>
                </c:pt>
                <c:pt idx="20">
                  <c:v>6.0306642292701218</c:v>
                </c:pt>
                <c:pt idx="21">
                  <c:v>11.378278646878559</c:v>
                </c:pt>
                <c:pt idx="22">
                  <c:v>0.293309847197394</c:v>
                </c:pt>
                <c:pt idx="25" formatCode="###0.00;\-###0.00">
                  <c:v>0.98697292387522795</c:v>
                </c:pt>
                <c:pt idx="26" formatCode="###0.00;\-###0.00">
                  <c:v>0.84736556792616302</c:v>
                </c:pt>
                <c:pt idx="27" formatCode="###0.00;\-###0.00">
                  <c:v>1.7647513343930781</c:v>
                </c:pt>
                <c:pt idx="28" formatCode="###0.00;\-###0.00">
                  <c:v>2.8242668588172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594048"/>
        <c:axId val="212604032"/>
      </c:barChart>
      <c:catAx>
        <c:axId val="212594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2225">
            <a:solidFill>
              <a:schemeClr val="tx1"/>
            </a:solidFill>
          </a:ln>
        </c:spPr>
        <c:crossAx val="212604032"/>
        <c:crosses val="autoZero"/>
        <c:auto val="1"/>
        <c:lblAlgn val="ctr"/>
        <c:lblOffset val="100"/>
        <c:noMultiLvlLbl val="0"/>
      </c:catAx>
      <c:valAx>
        <c:axId val="212604032"/>
        <c:scaling>
          <c:orientation val="minMax"/>
          <c:max val="12"/>
        </c:scaling>
        <c:delete val="0"/>
        <c:axPos val="l"/>
        <c:majorGridlines>
          <c:spPr>
            <a:ln>
              <a:noFill/>
            </a:ln>
          </c:spPr>
        </c:majorGridlines>
        <c:numFmt formatCode="#,##0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>
                <a:latin typeface="+mj-lt"/>
                <a:cs typeface="Times New Roman" panose="02020603050405020304" pitchFamily="18" charset="0"/>
              </a:defRPr>
            </a:pPr>
            <a:endParaRPr lang="zh-CN"/>
          </a:p>
        </c:txPr>
        <c:crossAx val="212594048"/>
        <c:crosses val="autoZero"/>
        <c:crossBetween val="between"/>
        <c:majorUnit val="3"/>
      </c:valAx>
    </c:plotArea>
    <c:legend>
      <c:legendPos val="r"/>
      <c:layout>
        <c:manualLayout>
          <c:xMode val="edge"/>
          <c:yMode val="edge"/>
          <c:x val="0.25247772233307197"/>
          <c:y val="1.8715849141611801E-3"/>
          <c:w val="0.57957026598836803"/>
          <c:h val="0.13757786264740901"/>
        </c:manualLayout>
      </c:layout>
      <c:overlay val="0"/>
      <c:txPr>
        <a:bodyPr/>
        <a:lstStyle/>
        <a:p>
          <a:pPr>
            <a:defRPr b="1">
              <a:latin typeface="+mj-lt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ln w="22225">
      <a:noFill/>
    </a:ln>
  </c:sp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8168455024859699E-2"/>
          <c:y val="0.13135289906943401"/>
          <c:w val="0.86603004166173903"/>
          <c:h val="0.782791000556748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4:$A$32</c:f>
              <c:numCache>
                <c:formatCode>General</c:formatCode>
                <c:ptCount val="29"/>
              </c:numCache>
            </c:numRef>
          </c:cat>
          <c:val>
            <c:numRef>
              <c:f>Sheet1!$B$4:$B$32</c:f>
              <c:numCache>
                <c:formatCode>General</c:formatCode>
                <c:ptCount val="29"/>
                <c:pt idx="0">
                  <c:v>0.95942979791215</c:v>
                </c:pt>
                <c:pt idx="1">
                  <c:v>1.422493097954981</c:v>
                </c:pt>
                <c:pt idx="2">
                  <c:v>0.74883467837518203</c:v>
                </c:pt>
                <c:pt idx="3">
                  <c:v>0.49615563794602802</c:v>
                </c:pt>
                <c:pt idx="4">
                  <c:v>1.233845413162695</c:v>
                </c:pt>
                <c:pt idx="5">
                  <c:v>1.563029115425284</c:v>
                </c:pt>
                <c:pt idx="6">
                  <c:v>1.3276728080934701</c:v>
                </c:pt>
                <c:pt idx="7">
                  <c:v>1.1368923481193809</c:v>
                </c:pt>
                <c:pt idx="8">
                  <c:v>1.386918153867597</c:v>
                </c:pt>
                <c:pt idx="9">
                  <c:v>0.94408532061570805</c:v>
                </c:pt>
                <c:pt idx="10">
                  <c:v>0.957252980709969</c:v>
                </c:pt>
                <c:pt idx="13">
                  <c:v>1.07190730558715</c:v>
                </c:pt>
                <c:pt idx="14">
                  <c:v>0.89692928598244603</c:v>
                </c:pt>
                <c:pt idx="15">
                  <c:v>0.99832063549324102</c:v>
                </c:pt>
                <c:pt idx="16">
                  <c:v>1.3998892085759611</c:v>
                </c:pt>
                <c:pt idx="17">
                  <c:v>0.61284755383874201</c:v>
                </c:pt>
                <c:pt idx="18">
                  <c:v>1.152297031009788</c:v>
                </c:pt>
                <c:pt idx="19">
                  <c:v>2.235364585363723</c:v>
                </c:pt>
                <c:pt idx="20">
                  <c:v>0.62687106835152595</c:v>
                </c:pt>
                <c:pt idx="21">
                  <c:v>1.1940172277154919</c:v>
                </c:pt>
                <c:pt idx="22">
                  <c:v>0.94986188121691295</c:v>
                </c:pt>
                <c:pt idx="25">
                  <c:v>1.3327555154137101</c:v>
                </c:pt>
                <c:pt idx="26">
                  <c:v>1.3783030706152539</c:v>
                </c:pt>
                <c:pt idx="27">
                  <c:v>0.72508606478940896</c:v>
                </c:pt>
                <c:pt idx="28">
                  <c:v>1.370479409163311</c:v>
                </c:pt>
              </c:numCache>
            </c:numRef>
          </c:val>
        </c:ser>
        <c:ser>
          <c:idx val="1"/>
          <c:order val="1"/>
          <c:tx>
            <c:strRef>
              <c:f>Sheet1!$C$3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4:$A$32</c:f>
              <c:numCache>
                <c:formatCode>General</c:formatCode>
                <c:ptCount val="29"/>
              </c:numCache>
            </c:numRef>
          </c:cat>
          <c:val>
            <c:numRef>
              <c:f>Sheet1!$C$4:$C$32</c:f>
              <c:numCache>
                <c:formatCode>General</c:formatCode>
                <c:ptCount val="29"/>
                <c:pt idx="0">
                  <c:v>1.3357246640688021</c:v>
                </c:pt>
                <c:pt idx="1">
                  <c:v>0.76331537310266995</c:v>
                </c:pt>
                <c:pt idx="2">
                  <c:v>1.4300574962135839</c:v>
                </c:pt>
                <c:pt idx="3">
                  <c:v>1.75117425811734</c:v>
                </c:pt>
                <c:pt idx="4">
                  <c:v>1.6247605912962599</c:v>
                </c:pt>
                <c:pt idx="5">
                  <c:v>6.333470036242125</c:v>
                </c:pt>
                <c:pt idx="6">
                  <c:v>0.80519139107418702</c:v>
                </c:pt>
                <c:pt idx="7">
                  <c:v>2.3234541127145829</c:v>
                </c:pt>
                <c:pt idx="8">
                  <c:v>2.7237053711545731</c:v>
                </c:pt>
                <c:pt idx="9">
                  <c:v>1.462481781181808</c:v>
                </c:pt>
                <c:pt idx="10">
                  <c:v>1.2063475862887201</c:v>
                </c:pt>
                <c:pt idx="13">
                  <c:v>2.3846543273995371</c:v>
                </c:pt>
                <c:pt idx="14">
                  <c:v>1.622374242144303</c:v>
                </c:pt>
                <c:pt idx="15">
                  <c:v>1.522936883901596</c:v>
                </c:pt>
                <c:pt idx="16">
                  <c:v>3.364129290608898</c:v>
                </c:pt>
                <c:pt idx="17">
                  <c:v>1.3930843867087499</c:v>
                </c:pt>
                <c:pt idx="18">
                  <c:v>2.078780819161036</c:v>
                </c:pt>
                <c:pt idx="19">
                  <c:v>3.0609811328811571</c:v>
                </c:pt>
                <c:pt idx="20">
                  <c:v>2.4693428406778759</c:v>
                </c:pt>
                <c:pt idx="21">
                  <c:v>3.3390441109807769</c:v>
                </c:pt>
                <c:pt idx="22">
                  <c:v>1.7528823305310881</c:v>
                </c:pt>
                <c:pt idx="25">
                  <c:v>2.146158537577433</c:v>
                </c:pt>
                <c:pt idx="26">
                  <c:v>2.5730966575797809</c:v>
                </c:pt>
                <c:pt idx="27">
                  <c:v>1.0872002194939341</c:v>
                </c:pt>
                <c:pt idx="28">
                  <c:v>1.37564684735675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665472"/>
        <c:axId val="212667008"/>
      </c:barChart>
      <c:catAx>
        <c:axId val="212665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212667008"/>
        <c:crossesAt val="1E-3"/>
        <c:auto val="1"/>
        <c:lblAlgn val="ctr"/>
        <c:lblOffset val="100"/>
        <c:noMultiLvlLbl val="0"/>
      </c:catAx>
      <c:valAx>
        <c:axId val="21266700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212665472"/>
        <c:crosses val="autoZero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214417297567046"/>
          <c:y val="0"/>
          <c:w val="0.61009132658056697"/>
          <c:h val="0.15058930843871801"/>
        </c:manualLayout>
      </c:layout>
      <c:overlay val="0"/>
      <c:txPr>
        <a:bodyPr/>
        <a:lstStyle/>
        <a:p>
          <a:pPr>
            <a:defRPr sz="1000"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8168455024859699E-2"/>
          <c:y val="0.13924431321084901"/>
          <c:w val="0.86603004166173903"/>
          <c:h val="0.774913877952756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4:$A$32</c:f>
              <c:numCache>
                <c:formatCode>General</c:formatCode>
                <c:ptCount val="29"/>
              </c:numCache>
            </c:numRef>
          </c:cat>
          <c:val>
            <c:numRef>
              <c:f>Sheet1!$B$4:$B$32</c:f>
              <c:numCache>
                <c:formatCode>General</c:formatCode>
                <c:ptCount val="29"/>
                <c:pt idx="0">
                  <c:v>0.81764592298952299</c:v>
                </c:pt>
                <c:pt idx="1">
                  <c:v>0.410683141870268</c:v>
                </c:pt>
                <c:pt idx="2">
                  <c:v>0.79670450203427701</c:v>
                </c:pt>
                <c:pt idx="3">
                  <c:v>0.195783980804112</c:v>
                </c:pt>
                <c:pt idx="4">
                  <c:v>0.76492310566863797</c:v>
                </c:pt>
                <c:pt idx="5">
                  <c:v>0.94339027403494002</c:v>
                </c:pt>
                <c:pt idx="6">
                  <c:v>0.79032181301982696</c:v>
                </c:pt>
                <c:pt idx="7">
                  <c:v>0.39557458198434098</c:v>
                </c:pt>
                <c:pt idx="8">
                  <c:v>0.62997222704079303</c:v>
                </c:pt>
                <c:pt idx="9">
                  <c:v>1.208993620945096</c:v>
                </c:pt>
                <c:pt idx="10">
                  <c:v>0.46426039958133603</c:v>
                </c:pt>
                <c:pt idx="13">
                  <c:v>0.31728849891751698</c:v>
                </c:pt>
                <c:pt idx="14">
                  <c:v>0.22952506776638201</c:v>
                </c:pt>
                <c:pt idx="15">
                  <c:v>1.1329727266438201</c:v>
                </c:pt>
                <c:pt idx="16">
                  <c:v>0.88195541590717297</c:v>
                </c:pt>
                <c:pt idx="17">
                  <c:v>0.57871748256135402</c:v>
                </c:pt>
                <c:pt idx="18">
                  <c:v>0.70848446890963002</c:v>
                </c:pt>
                <c:pt idx="19">
                  <c:v>1.637559278862093</c:v>
                </c:pt>
                <c:pt idx="20">
                  <c:v>0.123104988755358</c:v>
                </c:pt>
                <c:pt idx="21">
                  <c:v>0.44757213739638901</c:v>
                </c:pt>
                <c:pt idx="22">
                  <c:v>0.52196053405960896</c:v>
                </c:pt>
                <c:pt idx="25">
                  <c:v>0.83690230870733995</c:v>
                </c:pt>
                <c:pt idx="26">
                  <c:v>0.64413283118008602</c:v>
                </c:pt>
                <c:pt idx="27">
                  <c:v>0.18020265003168701</c:v>
                </c:pt>
                <c:pt idx="28">
                  <c:v>0.91700571645055595</c:v>
                </c:pt>
              </c:numCache>
            </c:numRef>
          </c:val>
        </c:ser>
        <c:ser>
          <c:idx val="1"/>
          <c:order val="1"/>
          <c:tx>
            <c:strRef>
              <c:f>Sheet1!$C$3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4:$A$32</c:f>
              <c:numCache>
                <c:formatCode>General</c:formatCode>
                <c:ptCount val="29"/>
              </c:numCache>
            </c:numRef>
          </c:cat>
          <c:val>
            <c:numRef>
              <c:f>Sheet1!$C$4:$C$32</c:f>
              <c:numCache>
                <c:formatCode>General</c:formatCode>
                <c:ptCount val="29"/>
                <c:pt idx="0">
                  <c:v>0.98293923158803698</c:v>
                </c:pt>
                <c:pt idx="1">
                  <c:v>0.39469992014641597</c:v>
                </c:pt>
                <c:pt idx="2">
                  <c:v>0.365078757727688</c:v>
                </c:pt>
                <c:pt idx="3">
                  <c:v>1.6846940720436709</c:v>
                </c:pt>
                <c:pt idx="4">
                  <c:v>1.2977357377645571</c:v>
                </c:pt>
                <c:pt idx="5">
                  <c:v>2.7115290607097799</c:v>
                </c:pt>
                <c:pt idx="6">
                  <c:v>0.37907773619588703</c:v>
                </c:pt>
                <c:pt idx="7">
                  <c:v>0.90393480704796103</c:v>
                </c:pt>
                <c:pt idx="8">
                  <c:v>0.98706509269813303</c:v>
                </c:pt>
                <c:pt idx="9">
                  <c:v>0.82042942035057698</c:v>
                </c:pt>
                <c:pt idx="10">
                  <c:v>0.62909710684181996</c:v>
                </c:pt>
                <c:pt idx="13">
                  <c:v>2.953676107304557</c:v>
                </c:pt>
                <c:pt idx="14">
                  <c:v>1.5433375478623499</c:v>
                </c:pt>
                <c:pt idx="15">
                  <c:v>1.8063771383340039</c:v>
                </c:pt>
                <c:pt idx="16">
                  <c:v>1.2326537722158279</c:v>
                </c:pt>
                <c:pt idx="17">
                  <c:v>0.782065112589439</c:v>
                </c:pt>
                <c:pt idx="18">
                  <c:v>0.62357052118467005</c:v>
                </c:pt>
                <c:pt idx="19">
                  <c:v>1.0283580272659969</c:v>
                </c:pt>
                <c:pt idx="20">
                  <c:v>0.82571746896780096</c:v>
                </c:pt>
                <c:pt idx="21">
                  <c:v>3.174774521228461</c:v>
                </c:pt>
                <c:pt idx="22">
                  <c:v>1.4643750846298469</c:v>
                </c:pt>
                <c:pt idx="25">
                  <c:v>0.78914517361804204</c:v>
                </c:pt>
                <c:pt idx="26">
                  <c:v>1.631813445008228</c:v>
                </c:pt>
                <c:pt idx="27">
                  <c:v>0.11949822818547801</c:v>
                </c:pt>
                <c:pt idx="28">
                  <c:v>1.0857979253962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737024"/>
        <c:axId val="212738816"/>
      </c:barChart>
      <c:catAx>
        <c:axId val="212737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212738816"/>
        <c:crossesAt val="1E-3"/>
        <c:auto val="1"/>
        <c:lblAlgn val="ctr"/>
        <c:lblOffset val="100"/>
        <c:noMultiLvlLbl val="0"/>
      </c:catAx>
      <c:valAx>
        <c:axId val="21273881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2127370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8934710101670499"/>
          <c:y val="0"/>
          <c:w val="0.65020364106111295"/>
          <c:h val="0.13480648015589"/>
        </c:manualLayout>
      </c:layout>
      <c:overlay val="0"/>
      <c:txPr>
        <a:bodyPr/>
        <a:lstStyle/>
        <a:p>
          <a:pPr>
            <a:defRPr sz="1000"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8168455024859699E-2"/>
          <c:y val="0.12346148492802"/>
          <c:w val="0.86603004166173903"/>
          <c:h val="0.790696706235583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non-tumor</c:v>
                </c:pt>
              </c:strCache>
            </c:strRef>
          </c:tx>
          <c:invertIfNegative val="0"/>
          <c:cat>
            <c:numRef>
              <c:f>Sheet1!$A$4:$A$32</c:f>
              <c:numCache>
                <c:formatCode>General</c:formatCode>
                <c:ptCount val="29"/>
              </c:numCache>
            </c:numRef>
          </c:cat>
          <c:val>
            <c:numRef>
              <c:f>Sheet1!$B$4:$B$32</c:f>
              <c:numCache>
                <c:formatCode>General</c:formatCode>
                <c:ptCount val="29"/>
                <c:pt idx="0">
                  <c:v>0.97549248882006401</c:v>
                </c:pt>
                <c:pt idx="1">
                  <c:v>0.53612643198879395</c:v>
                </c:pt>
                <c:pt idx="2">
                  <c:v>0.420757872280418</c:v>
                </c:pt>
                <c:pt idx="3">
                  <c:v>0.45873540690639503</c:v>
                </c:pt>
                <c:pt idx="4">
                  <c:v>0.96997916871222301</c:v>
                </c:pt>
                <c:pt idx="5">
                  <c:v>0.89067664473807295</c:v>
                </c:pt>
                <c:pt idx="6">
                  <c:v>0.78445177802896204</c:v>
                </c:pt>
                <c:pt idx="7">
                  <c:v>0.52764907971112596</c:v>
                </c:pt>
                <c:pt idx="8">
                  <c:v>0.86980636392160404</c:v>
                </c:pt>
                <c:pt idx="9">
                  <c:v>0.86245534704111204</c:v>
                </c:pt>
                <c:pt idx="10">
                  <c:v>1.168706501160214</c:v>
                </c:pt>
                <c:pt idx="13">
                  <c:v>1.113696145284244</c:v>
                </c:pt>
                <c:pt idx="14">
                  <c:v>1.13057889378704</c:v>
                </c:pt>
                <c:pt idx="15">
                  <c:v>0.69427333570671601</c:v>
                </c:pt>
                <c:pt idx="16">
                  <c:v>1.041447900875444</c:v>
                </c:pt>
                <c:pt idx="17">
                  <c:v>0.73070484044444795</c:v>
                </c:pt>
                <c:pt idx="18">
                  <c:v>1.02424877645238</c:v>
                </c:pt>
                <c:pt idx="19">
                  <c:v>1.614589785043733</c:v>
                </c:pt>
                <c:pt idx="20">
                  <c:v>0.750627821803588</c:v>
                </c:pt>
                <c:pt idx="21">
                  <c:v>0.72470018584403095</c:v>
                </c:pt>
                <c:pt idx="22">
                  <c:v>0.78087101605657006</c:v>
                </c:pt>
                <c:pt idx="25">
                  <c:v>1.246759476993976</c:v>
                </c:pt>
                <c:pt idx="26">
                  <c:v>1.086688288563703</c:v>
                </c:pt>
                <c:pt idx="27">
                  <c:v>0.58230490218999298</c:v>
                </c:pt>
                <c:pt idx="28">
                  <c:v>0.77267930828751297</c:v>
                </c:pt>
              </c:numCache>
            </c:numRef>
          </c:val>
        </c:ser>
        <c:ser>
          <c:idx val="1"/>
          <c:order val="1"/>
          <c:tx>
            <c:strRef>
              <c:f>Sheet1!$C$3</c:f>
              <c:strCache>
                <c:ptCount val="1"/>
                <c:pt idx="0">
                  <c:v>tumor</c:v>
                </c:pt>
              </c:strCache>
            </c:strRef>
          </c:tx>
          <c:invertIfNegative val="0"/>
          <c:cat>
            <c:numRef>
              <c:f>Sheet1!$A$4:$A$32</c:f>
              <c:numCache>
                <c:formatCode>General</c:formatCode>
                <c:ptCount val="29"/>
              </c:numCache>
            </c:numRef>
          </c:cat>
          <c:val>
            <c:numRef>
              <c:f>Sheet1!$C$4:$C$32</c:f>
              <c:numCache>
                <c:formatCode>General</c:formatCode>
                <c:ptCount val="29"/>
                <c:pt idx="0">
                  <c:v>1.4717224990882321</c:v>
                </c:pt>
                <c:pt idx="1">
                  <c:v>1.0910393755647509</c:v>
                </c:pt>
                <c:pt idx="2">
                  <c:v>0.41427859023388203</c:v>
                </c:pt>
                <c:pt idx="3">
                  <c:v>1.036619666388088</c:v>
                </c:pt>
                <c:pt idx="4">
                  <c:v>1.2166419625473359</c:v>
                </c:pt>
                <c:pt idx="5">
                  <c:v>1.330008687582287</c:v>
                </c:pt>
                <c:pt idx="6">
                  <c:v>0.548589026590937</c:v>
                </c:pt>
                <c:pt idx="7">
                  <c:v>2.3844229582948442</c:v>
                </c:pt>
                <c:pt idx="8">
                  <c:v>0.90895461705339697</c:v>
                </c:pt>
                <c:pt idx="9">
                  <c:v>1.7450134658435881</c:v>
                </c:pt>
                <c:pt idx="10">
                  <c:v>1.180262014864178</c:v>
                </c:pt>
                <c:pt idx="13">
                  <c:v>1.9518235960625561</c:v>
                </c:pt>
                <c:pt idx="14">
                  <c:v>0.85050414340576097</c:v>
                </c:pt>
                <c:pt idx="15">
                  <c:v>2.517858432703346</c:v>
                </c:pt>
                <c:pt idx="16">
                  <c:v>2.2727912294769799</c:v>
                </c:pt>
                <c:pt idx="17">
                  <c:v>0.74053620157731503</c:v>
                </c:pt>
                <c:pt idx="18">
                  <c:v>0.53394041897157596</c:v>
                </c:pt>
                <c:pt idx="19">
                  <c:v>2.9671136122917172</c:v>
                </c:pt>
                <c:pt idx="20">
                  <c:v>1.544429663755319</c:v>
                </c:pt>
                <c:pt idx="21">
                  <c:v>1.7659746936919569</c:v>
                </c:pt>
                <c:pt idx="22">
                  <c:v>0.62510964579637895</c:v>
                </c:pt>
                <c:pt idx="25">
                  <c:v>1.0941353133402321</c:v>
                </c:pt>
                <c:pt idx="26">
                  <c:v>2.8874293950213512</c:v>
                </c:pt>
                <c:pt idx="27">
                  <c:v>0.50690126501211796</c:v>
                </c:pt>
                <c:pt idx="28">
                  <c:v>0.793959966212262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57120"/>
        <c:axId val="212358656"/>
      </c:barChart>
      <c:catAx>
        <c:axId val="212357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212358656"/>
        <c:crossesAt val="1E-3"/>
        <c:auto val="1"/>
        <c:lblAlgn val="ctr"/>
        <c:lblOffset val="100"/>
        <c:noMultiLvlLbl val="0"/>
      </c:catAx>
      <c:valAx>
        <c:axId val="21235865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21235712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0485486189226301"/>
          <c:y val="0"/>
          <c:w val="0.64627077865266802"/>
          <c:h val="0.126915066014475"/>
        </c:manualLayout>
      </c:layout>
      <c:overlay val="0"/>
      <c:txPr>
        <a:bodyPr/>
        <a:lstStyle/>
        <a:p>
          <a:pPr>
            <a:defRPr sz="1000" b="1">
              <a:latin typeface="+mj-lt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466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285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32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679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54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542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6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455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30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22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481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1BA886-AB20-4D9D-9D44-C265381050C4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53569-B549-4E41-9080-0A903F079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614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381000" y="558225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a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332160" y="558225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b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81000" y="2768025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c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9444674"/>
              </p:ext>
            </p:extLst>
          </p:nvPr>
        </p:nvGraphicFramePr>
        <p:xfrm>
          <a:off x="510084" y="3043496"/>
          <a:ext cx="2631131" cy="15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2" name="Straight Connector 31"/>
          <p:cNvCxnSpPr/>
          <p:nvPr/>
        </p:nvCxnSpPr>
        <p:spPr>
          <a:xfrm>
            <a:off x="2859891" y="4551983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2685636" y="4536389"/>
            <a:ext cx="933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41" name="Straight Connector 40"/>
          <p:cNvCxnSpPr/>
          <p:nvPr/>
        </p:nvCxnSpPr>
        <p:spPr>
          <a:xfrm>
            <a:off x="1968938" y="4551983"/>
            <a:ext cx="70452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2009071" y="4536389"/>
            <a:ext cx="10389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>
            <a:off x="933036" y="4555553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933036" y="4536389"/>
            <a:ext cx="868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605001" y="285920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H19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5932589" y="4549505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5763922" y="4526637"/>
            <a:ext cx="7996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60" name="Straight Connector 59"/>
          <p:cNvCxnSpPr/>
          <p:nvPr/>
        </p:nvCxnSpPr>
        <p:spPr>
          <a:xfrm>
            <a:off x="4996334" y="4549505"/>
            <a:ext cx="7498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5014711" y="4526637"/>
            <a:ext cx="967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62" name="Straight Connector 61"/>
          <p:cNvCxnSpPr/>
          <p:nvPr/>
        </p:nvCxnSpPr>
        <p:spPr>
          <a:xfrm>
            <a:off x="3955373" y="4553075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4047397" y="4526637"/>
            <a:ext cx="8911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64" name="Char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0369979"/>
              </p:ext>
            </p:extLst>
          </p:nvPr>
        </p:nvGraphicFramePr>
        <p:xfrm>
          <a:off x="3600036" y="3026811"/>
          <a:ext cx="2617991" cy="15288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5" name="TextBox 64"/>
          <p:cNvSpPr txBox="1"/>
          <p:nvPr/>
        </p:nvSpPr>
        <p:spPr>
          <a:xfrm>
            <a:off x="4731277" y="2805514"/>
            <a:ext cx="529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HULC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67" name="Chart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2955525"/>
              </p:ext>
            </p:extLst>
          </p:nvPr>
        </p:nvGraphicFramePr>
        <p:xfrm>
          <a:off x="510084" y="5150493"/>
          <a:ext cx="2621280" cy="15288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68" name="Straight Connector 67"/>
          <p:cNvCxnSpPr/>
          <p:nvPr/>
        </p:nvCxnSpPr>
        <p:spPr>
          <a:xfrm>
            <a:off x="2859891" y="6654451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2632333" y="6636640"/>
            <a:ext cx="811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>
            <a:off x="1923636" y="6654451"/>
            <a:ext cx="7498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1957028" y="6636640"/>
            <a:ext cx="862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72" name="Straight Connector 71"/>
          <p:cNvCxnSpPr/>
          <p:nvPr/>
        </p:nvCxnSpPr>
        <p:spPr>
          <a:xfrm>
            <a:off x="933036" y="6654451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956118" y="6636640"/>
            <a:ext cx="794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605001" y="4935379"/>
            <a:ext cx="568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MEG3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332160" y="2768025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anose="02020603050405020304" pitchFamily="18" charset="0"/>
              </a:rPr>
              <a:t>d</a:t>
            </a:r>
            <a:endParaRPr lang="en-US" sz="1600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81000" y="4901625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e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7049421"/>
              </p:ext>
            </p:extLst>
          </p:nvPr>
        </p:nvGraphicFramePr>
        <p:xfrm>
          <a:off x="457200" y="873506"/>
          <a:ext cx="2695285" cy="1527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36" name="Straight Connector 35"/>
          <p:cNvCxnSpPr/>
          <p:nvPr/>
        </p:nvCxnSpPr>
        <p:spPr>
          <a:xfrm>
            <a:off x="2859891" y="2370847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2685636" y="2370847"/>
            <a:ext cx="933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38" name="Straight Connector 37"/>
          <p:cNvCxnSpPr/>
          <p:nvPr/>
        </p:nvCxnSpPr>
        <p:spPr>
          <a:xfrm>
            <a:off x="1923636" y="2370847"/>
            <a:ext cx="7498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923636" y="2370847"/>
            <a:ext cx="10389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>
            <a:off x="933036" y="2374417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933036" y="2370847"/>
            <a:ext cx="868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605001" y="656992"/>
            <a:ext cx="5725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ANRIL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45" name="Chart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0718622"/>
              </p:ext>
            </p:extLst>
          </p:nvPr>
        </p:nvGraphicFramePr>
        <p:xfrm>
          <a:off x="3443357" y="854486"/>
          <a:ext cx="2748155" cy="1527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46" name="Straight Connector 45"/>
          <p:cNvCxnSpPr/>
          <p:nvPr/>
        </p:nvCxnSpPr>
        <p:spPr>
          <a:xfrm>
            <a:off x="5888593" y="2370847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5695702" y="2368995"/>
            <a:ext cx="933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>
            <a:off x="4922736" y="2370847"/>
            <a:ext cx="7498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4922736" y="2370847"/>
            <a:ext cx="10389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3932136" y="2374417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3932136" y="2370847"/>
            <a:ext cx="868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731277" y="656991"/>
            <a:ext cx="6624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HOTTIP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66" name="Chart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3275726"/>
              </p:ext>
            </p:extLst>
          </p:nvPr>
        </p:nvGraphicFramePr>
        <p:xfrm>
          <a:off x="3687578" y="5141136"/>
          <a:ext cx="2530449" cy="1527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75" name="TextBox 74"/>
          <p:cNvSpPr txBox="1"/>
          <p:nvPr/>
        </p:nvSpPr>
        <p:spPr>
          <a:xfrm>
            <a:off x="4731277" y="4923966"/>
            <a:ext cx="4972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HEIH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>
            <a:off x="5948707" y="6654451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5791200" y="6636640"/>
            <a:ext cx="811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78" name="Straight Connector 77"/>
          <p:cNvCxnSpPr/>
          <p:nvPr/>
        </p:nvCxnSpPr>
        <p:spPr>
          <a:xfrm>
            <a:off x="4985937" y="6647733"/>
            <a:ext cx="7611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5005028" y="6636640"/>
            <a:ext cx="862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>
            <a:off x="3962400" y="6654451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4013714" y="6636640"/>
            <a:ext cx="794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332160" y="4901625"/>
            <a:ext cx="250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anose="02020603050405020304" pitchFamily="18" charset="0"/>
              </a:rPr>
              <a:t>f</a:t>
            </a:r>
            <a:endParaRPr lang="en-US" sz="1600" b="1" dirty="0">
              <a:latin typeface="+mj-lt"/>
              <a:cs typeface="Times New Roman" panose="02020603050405020304" pitchFamily="18" charset="0"/>
            </a:endParaRPr>
          </a:p>
        </p:txBody>
      </p:sp>
      <p:graphicFrame>
        <p:nvGraphicFramePr>
          <p:cNvPr id="83" name="Chart 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4918832"/>
              </p:ext>
            </p:extLst>
          </p:nvPr>
        </p:nvGraphicFramePr>
        <p:xfrm>
          <a:off x="762000" y="7212235"/>
          <a:ext cx="2532888" cy="1609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84" name="TextBox 83"/>
          <p:cNvSpPr txBox="1"/>
          <p:nvPr/>
        </p:nvSpPr>
        <p:spPr>
          <a:xfrm>
            <a:off x="1605001" y="7014706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PCNA-AS1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81000" y="6891523"/>
            <a:ext cx="282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g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86" name="Straight Connector 85"/>
          <p:cNvCxnSpPr/>
          <p:nvPr/>
        </p:nvCxnSpPr>
        <p:spPr>
          <a:xfrm>
            <a:off x="2920529" y="8747984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2763022" y="8736891"/>
            <a:ext cx="811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88" name="Straight Connector 87"/>
          <p:cNvCxnSpPr/>
          <p:nvPr/>
        </p:nvCxnSpPr>
        <p:spPr>
          <a:xfrm>
            <a:off x="2001875" y="8747984"/>
            <a:ext cx="7611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2033228" y="8745379"/>
            <a:ext cx="862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90" name="Straight Connector 89"/>
          <p:cNvCxnSpPr/>
          <p:nvPr/>
        </p:nvCxnSpPr>
        <p:spPr>
          <a:xfrm>
            <a:off x="978338" y="8754702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1029652" y="8736891"/>
            <a:ext cx="794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332160" y="6891523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h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94" name="Chart 9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1484516"/>
              </p:ext>
            </p:extLst>
          </p:nvPr>
        </p:nvGraphicFramePr>
        <p:xfrm>
          <a:off x="3768261" y="7212235"/>
          <a:ext cx="2532888" cy="1609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cxnSp>
        <p:nvCxnSpPr>
          <p:cNvPr id="95" name="Straight Connector 94"/>
          <p:cNvCxnSpPr/>
          <p:nvPr/>
        </p:nvCxnSpPr>
        <p:spPr>
          <a:xfrm>
            <a:off x="5916172" y="8756472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5758665" y="8745379"/>
            <a:ext cx="811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97" name="Straight Connector 96"/>
          <p:cNvCxnSpPr/>
          <p:nvPr/>
        </p:nvCxnSpPr>
        <p:spPr>
          <a:xfrm>
            <a:off x="4997518" y="8756472"/>
            <a:ext cx="7611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5005028" y="8745379"/>
            <a:ext cx="862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99" name="Straight Connector 98"/>
          <p:cNvCxnSpPr/>
          <p:nvPr/>
        </p:nvCxnSpPr>
        <p:spPr>
          <a:xfrm>
            <a:off x="3973981" y="8763190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4025295" y="8745379"/>
            <a:ext cx="794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731277" y="7020402"/>
            <a:ext cx="515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UFC1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381000" y="153568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  <a:cs typeface="Times New Roman" pitchFamily="18" charset="0"/>
              </a:rPr>
              <a:t>Figure S1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5511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7200" y="2590800"/>
            <a:ext cx="5867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CC-associate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lncRNA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tumor and surrounding non-tumorous tissue in a series of patients with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CC associate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BV, HCV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DV analyz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q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R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PC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The expressio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level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ncRNA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e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ormalize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o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house keeping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gen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APDH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Y axis indicate the relative expression of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ncRNA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which was calculated as described in the Materials and Methods.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ANRIL;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HOTTIP;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H19;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HULC;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MEG3;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HEIH;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g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PCNA-AS1;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UFC1; (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ZEB-AS1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734337"/>
              </p:ext>
            </p:extLst>
          </p:nvPr>
        </p:nvGraphicFramePr>
        <p:xfrm>
          <a:off x="757091" y="679037"/>
          <a:ext cx="2560320" cy="1609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Straight Connector 5"/>
          <p:cNvCxnSpPr/>
          <p:nvPr/>
        </p:nvCxnSpPr>
        <p:spPr>
          <a:xfrm>
            <a:off x="2927882" y="2230037"/>
            <a:ext cx="2693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770375" y="2218944"/>
            <a:ext cx="811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D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2009228" y="2230037"/>
            <a:ext cx="7611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033228" y="2218944"/>
            <a:ext cx="862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C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985691" y="2236755"/>
            <a:ext cx="855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037005" y="2218944"/>
            <a:ext cx="794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+mj-lt"/>
                <a:cs typeface="Times New Roman" pitchFamily="18" charset="0"/>
              </a:rPr>
              <a:t>HBV-HCC</a:t>
            </a:r>
            <a:endParaRPr lang="en-US" sz="1000" b="1" dirty="0">
              <a:latin typeface="+mj-lt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12125" y="340483"/>
            <a:ext cx="2391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+mj-lt"/>
                <a:cs typeface="Times New Roman" pitchFamily="18" charset="0"/>
              </a:rPr>
              <a:t>i</a:t>
            </a:r>
            <a:endParaRPr lang="en-US" sz="1600" b="1" dirty="0">
              <a:latin typeface="+mj-lt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649401" y="475300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+mj-lt"/>
                <a:cs typeface="Times New Roman" pitchFamily="18" charset="0"/>
              </a:rPr>
              <a:t>ZEB1-AS1</a:t>
            </a:r>
            <a:endParaRPr lang="en-US" sz="1200" b="1" dirty="0">
              <a:latin typeface="+mj-lt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64827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83</TotalTime>
  <Words>158</Words>
  <Application>Microsoft Office PowerPoint</Application>
  <PresentationFormat>全屏显示(4:3)</PresentationFormat>
  <Paragraphs>47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Theme</vt:lpstr>
      <vt:lpstr>PowerPoint 演示文稿</vt:lpstr>
      <vt:lpstr>PowerPoint 演示文稿</vt:lpstr>
    </vt:vector>
  </TitlesOfParts>
  <Company>NIAI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Quan (NIH/NIAID) [F]</dc:creator>
  <cp:lastModifiedBy>Ting</cp:lastModifiedBy>
  <cp:revision>84</cp:revision>
  <dcterms:created xsi:type="dcterms:W3CDTF">2015-08-03T13:40:54Z</dcterms:created>
  <dcterms:modified xsi:type="dcterms:W3CDTF">2016-10-21T01:16:32Z</dcterms:modified>
</cp:coreProperties>
</file>